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10" d="100"/>
          <a:sy n="110" d="100"/>
        </p:scale>
        <p:origin x="594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73064-AB41-4798-BAAE-07DD7F72FEF0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E5983-1367-4714-A6A4-8C3C8EBAF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4981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73064-AB41-4798-BAAE-07DD7F72FEF0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E5983-1367-4714-A6A4-8C3C8EBAF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06428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73064-AB41-4798-BAAE-07DD7F72FEF0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E5983-1367-4714-A6A4-8C3C8EBAF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20779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73064-AB41-4798-BAAE-07DD7F72FEF0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E5983-1367-4714-A6A4-8C3C8EBAF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2418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73064-AB41-4798-BAAE-07DD7F72FEF0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E5983-1367-4714-A6A4-8C3C8EBAF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1713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73064-AB41-4798-BAAE-07DD7F72FEF0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E5983-1367-4714-A6A4-8C3C8EBAF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1557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73064-AB41-4798-BAAE-07DD7F72FEF0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E5983-1367-4714-A6A4-8C3C8EBAF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59190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73064-AB41-4798-BAAE-07DD7F72FEF0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E5983-1367-4714-A6A4-8C3C8EBAF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262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73064-AB41-4798-BAAE-07DD7F72FEF0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E5983-1367-4714-A6A4-8C3C8EBAF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73316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73064-AB41-4798-BAAE-07DD7F72FEF0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E5983-1367-4714-A6A4-8C3C8EBAF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2895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73064-AB41-4798-BAAE-07DD7F72FEF0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E5983-1367-4714-A6A4-8C3C8EBAF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9760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173064-AB41-4798-BAAE-07DD7F72FEF0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CE5983-1367-4714-A6A4-8C3C8EBAF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873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6957" y="0"/>
            <a:ext cx="2998085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70723" y="0"/>
            <a:ext cx="24188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Supplementary Figure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206473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9238"/>
          <a:stretch/>
        </p:blipFill>
        <p:spPr>
          <a:xfrm>
            <a:off x="2368731" y="357052"/>
            <a:ext cx="6845599" cy="6363793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70723" y="0"/>
            <a:ext cx="24188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Supplementary Figure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947255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2490" y="0"/>
            <a:ext cx="7527020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70723" y="0"/>
            <a:ext cx="24188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Supplementary Figure 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128113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7582" y="0"/>
            <a:ext cx="6996835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70723" y="0"/>
            <a:ext cx="24188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Supplementary Figure 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029574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6966" y="1847850"/>
            <a:ext cx="5878068" cy="31623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70723" y="0"/>
            <a:ext cx="24188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Supplementary Figure 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978996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1856" y="1213104"/>
            <a:ext cx="3828288" cy="4431792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70723" y="0"/>
            <a:ext cx="24188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Supplementary Figure 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9516659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9009" y="0"/>
            <a:ext cx="9493981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70723" y="0"/>
            <a:ext cx="24188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Supplementary Figure 7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218402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1</Words>
  <Application>Microsoft Office PowerPoint</Application>
  <PresentationFormat>Widescreen</PresentationFormat>
  <Paragraphs>7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zmalali</dc:creator>
  <cp:lastModifiedBy>azmalali</cp:lastModifiedBy>
  <cp:revision>1</cp:revision>
  <dcterms:created xsi:type="dcterms:W3CDTF">2020-06-01T19:19:50Z</dcterms:created>
  <dcterms:modified xsi:type="dcterms:W3CDTF">2020-06-01T19:24:05Z</dcterms:modified>
</cp:coreProperties>
</file>